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5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aximized">
    <p:restoredLeft sz="13560" autoAdjust="0"/>
    <p:restoredTop sz="79680" autoAdjust="0"/>
  </p:normalViewPr>
  <p:slideViewPr>
    <p:cSldViewPr>
      <p:cViewPr>
        <p:scale>
          <a:sx n="156" d="100"/>
          <a:sy n="156" d="100"/>
        </p:scale>
        <p:origin x="-1088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75D34E-A6F0-40B6-B9BF-F28BC9490060}" type="datetimeFigureOut">
              <a:rPr lang="en-US" smtClean="0"/>
              <a:t>13/8/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1B78C3-A112-42A1-81C1-EAE56F96F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49881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Table S1. List of primers used in PCR, real-time PCR and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in situ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hybridization.</a:t>
            </a:r>
            <a:endParaRPr lang="en-US" sz="120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1B78C3-A112-42A1-81C1-EAE56F96F99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38973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B82EB-CA33-4117-954D-C6E0DC1F7C83}" type="datetimeFigureOut">
              <a:rPr lang="en-US" smtClean="0"/>
              <a:t>13/8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51F44-00E8-46B3-965D-ACE94E07A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6234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B82EB-CA33-4117-954D-C6E0DC1F7C83}" type="datetimeFigureOut">
              <a:rPr lang="en-US" smtClean="0"/>
              <a:t>13/8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51F44-00E8-46B3-965D-ACE94E07A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5569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B82EB-CA33-4117-954D-C6E0DC1F7C83}" type="datetimeFigureOut">
              <a:rPr lang="en-US" smtClean="0"/>
              <a:t>13/8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51F44-00E8-46B3-965D-ACE94E07A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2891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B82EB-CA33-4117-954D-C6E0DC1F7C83}" type="datetimeFigureOut">
              <a:rPr lang="en-US" smtClean="0"/>
              <a:t>13/8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51F44-00E8-46B3-965D-ACE94E07A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794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B82EB-CA33-4117-954D-C6E0DC1F7C83}" type="datetimeFigureOut">
              <a:rPr lang="en-US" smtClean="0"/>
              <a:t>13/8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51F44-00E8-46B3-965D-ACE94E07A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73179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B82EB-CA33-4117-954D-C6E0DC1F7C83}" type="datetimeFigureOut">
              <a:rPr lang="en-US" smtClean="0"/>
              <a:t>13/8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51F44-00E8-46B3-965D-ACE94E07A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730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B82EB-CA33-4117-954D-C6E0DC1F7C83}" type="datetimeFigureOut">
              <a:rPr lang="en-US" smtClean="0"/>
              <a:t>13/8/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51F44-00E8-46B3-965D-ACE94E07A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0326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B82EB-CA33-4117-954D-C6E0DC1F7C83}" type="datetimeFigureOut">
              <a:rPr lang="en-US" smtClean="0"/>
              <a:t>13/8/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51F44-00E8-46B3-965D-ACE94E07A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56475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B82EB-CA33-4117-954D-C6E0DC1F7C83}" type="datetimeFigureOut">
              <a:rPr lang="en-US" smtClean="0"/>
              <a:t>13/8/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51F44-00E8-46B3-965D-ACE94E07A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9257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B82EB-CA33-4117-954D-C6E0DC1F7C83}" type="datetimeFigureOut">
              <a:rPr lang="en-US" smtClean="0"/>
              <a:t>13/8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51F44-00E8-46B3-965D-ACE94E07A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82018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B82EB-CA33-4117-954D-C6E0DC1F7C83}" type="datetimeFigureOut">
              <a:rPr lang="en-US" smtClean="0"/>
              <a:t>13/8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51F44-00E8-46B3-965D-ACE94E07A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9891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2B82EB-CA33-4117-954D-C6E0DC1F7C83}" type="datetimeFigureOut">
              <a:rPr lang="en-US" smtClean="0"/>
              <a:t>13/8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851F44-00E8-46B3-965D-ACE94E07A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780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95432627"/>
              </p:ext>
            </p:extLst>
          </p:nvPr>
        </p:nvGraphicFramePr>
        <p:xfrm>
          <a:off x="228600" y="212943"/>
          <a:ext cx="5410200" cy="8563332"/>
        </p:xfrm>
        <a:graphic>
          <a:graphicData uri="http://schemas.openxmlformats.org/drawingml/2006/table">
            <a:tbl>
              <a:tblPr/>
              <a:tblGrid>
                <a:gridCol w="990600"/>
                <a:gridCol w="1447800"/>
                <a:gridCol w="1143000"/>
                <a:gridCol w="1828800"/>
              </a:tblGrid>
              <a:tr h="3946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b="1" kern="100" dirty="0" smtClean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Target transcripts</a:t>
                      </a:r>
                      <a:endParaRPr lang="en-US" sz="600" b="1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b="1" kern="100" dirty="0" smtClean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Amplification</a:t>
                      </a:r>
                      <a:endParaRPr lang="en-US" sz="600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b="1" kern="10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Primer</a:t>
                      </a:r>
                      <a:endParaRPr lang="en-US" sz="600" kern="10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b="1" kern="100" dirty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Sequence (5’</a:t>
                      </a:r>
                      <a:r>
                        <a:rPr lang="en-US" sz="600" b="1" kern="100" dirty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  <a:sym typeface="Wingdings"/>
                        </a:rPr>
                        <a:t></a:t>
                      </a:r>
                      <a:r>
                        <a:rPr lang="en-US" sz="600" b="1" kern="100" dirty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3’)</a:t>
                      </a:r>
                      <a:endParaRPr lang="en-US" sz="600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0852">
                <a:tc rowSpan="1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600" b="1" kern="100" dirty="0" err="1" smtClean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jlpPHI</a:t>
                      </a:r>
                      <a:r>
                        <a:rPr lang="en-US" sz="600" b="1" kern="100" dirty="0" smtClean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/VIP</a:t>
                      </a:r>
                      <a:endParaRPr lang="en-US" sz="600" b="1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Partial </a:t>
                      </a:r>
                      <a:r>
                        <a:rPr lang="en-US" sz="600" kern="100" dirty="0" smtClean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clone</a:t>
                      </a:r>
                      <a:endParaRPr lang="en-US" sz="600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jlpVIP-F1</a:t>
                      </a:r>
                      <a:endParaRPr lang="en-US" sz="600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 pitchFamily="49" charset="0"/>
                          <a:ea typeface="新細明體"/>
                          <a:cs typeface="Courier New" pitchFamily="49" charset="0"/>
                        </a:rPr>
                        <a:t>CACTCGGACGCGGTGTTCAC</a:t>
                      </a: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1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jlpVIP-R1</a:t>
                      </a:r>
                      <a:endParaRPr lang="en-US" sz="600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 pitchFamily="49" charset="0"/>
                          <a:ea typeface="新細明體"/>
                          <a:cs typeface="Courier New" pitchFamily="49" charset="0"/>
                        </a:rPr>
                        <a:t>GGACAGAATGGACTTGGCGT</a:t>
                      </a: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endParaRPr lang="en-US" sz="800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5’RACE (1st round)</a:t>
                      </a: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AAP</a:t>
                      </a: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 pitchFamily="49" charset="0"/>
                          <a:ea typeface="新細明體"/>
                          <a:cs typeface="Courier New" pitchFamily="49" charset="0"/>
                        </a:rPr>
                        <a:t>GGCCACGCGTCGACTAGTACGGGIIGGGIIGGGII</a:t>
                      </a: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jlpVIP-5’R1</a:t>
                      </a:r>
                      <a:endParaRPr lang="en-US" sz="600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 pitchFamily="49" charset="0"/>
                          <a:ea typeface="新細明體"/>
                          <a:cs typeface="Courier New" pitchFamily="49" charset="0"/>
                        </a:rPr>
                        <a:t>CATAGTAGTCCTCCAG</a:t>
                      </a: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endParaRPr lang="en-US" sz="800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5’RACE (2nd round)</a:t>
                      </a: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AUAP</a:t>
                      </a: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 pitchFamily="49" charset="0"/>
                          <a:ea typeface="新細明體"/>
                          <a:cs typeface="Courier New" pitchFamily="49" charset="0"/>
                        </a:rPr>
                        <a:t>GGCCACGCGTCGACTAGTAC</a:t>
                      </a: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39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jlpVIP-5’R2</a:t>
                      </a:r>
                      <a:endParaRPr lang="en-US" sz="600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 pitchFamily="49" charset="0"/>
                          <a:ea typeface="新細明體"/>
                          <a:cs typeface="Courier New" pitchFamily="49" charset="0"/>
                        </a:rPr>
                        <a:t>AGTTGCCTTGCTCCGA</a:t>
                      </a: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endParaRPr lang="en-US" sz="800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3’RACE (1st round)</a:t>
                      </a: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jlpVIP-F1</a:t>
                      </a:r>
                      <a:endParaRPr lang="en-US" sz="600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 pitchFamily="49" charset="0"/>
                          <a:ea typeface="新細明體"/>
                          <a:cs typeface="Courier New" pitchFamily="49" charset="0"/>
                        </a:rPr>
                        <a:t>CACTCGGACGCGGTGTTCAC</a:t>
                      </a: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AUAP</a:t>
                      </a: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 pitchFamily="49" charset="0"/>
                          <a:ea typeface="新細明體"/>
                          <a:cs typeface="Courier New" pitchFamily="49" charset="0"/>
                        </a:rPr>
                        <a:t>GGCCACGCGTCGACTAGTAC</a:t>
                      </a: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1076">
                <a:tc vMerge="1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endParaRPr lang="en-US" sz="800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3’RACE (2nd round)</a:t>
                      </a: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jlpVIP-3’F2</a:t>
                      </a:r>
                      <a:endParaRPr lang="en-US" sz="600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 pitchFamily="49" charset="0"/>
                          <a:ea typeface="新細明體"/>
                          <a:cs typeface="Courier New" pitchFamily="49" charset="0"/>
                        </a:rPr>
                        <a:t>GCAAGCAGCAAGCGGCGGAG</a:t>
                      </a: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179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AUAP</a:t>
                      </a: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 pitchFamily="49" charset="0"/>
                          <a:ea typeface="新細明體"/>
                          <a:cs typeface="Courier New" pitchFamily="49" charset="0"/>
                        </a:rPr>
                        <a:t>GGCCACGCGTCGACTAGTAC</a:t>
                      </a: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349">
                <a:tc vMerge="1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endParaRPr lang="en-US" sz="800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Full  </a:t>
                      </a:r>
                      <a:r>
                        <a:rPr lang="en-US" sz="600" kern="100" dirty="0" smtClean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length clone (</a:t>
                      </a:r>
                      <a:r>
                        <a:rPr lang="en-US" sz="600" kern="100" dirty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1st round)</a:t>
                      </a: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jlpVIP-FLF1</a:t>
                      </a:r>
                      <a:endParaRPr lang="en-US" sz="600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 pitchFamily="49" charset="0"/>
                          <a:ea typeface="新細明體"/>
                          <a:cs typeface="Courier New" pitchFamily="49" charset="0"/>
                        </a:rPr>
                        <a:t>ACTGCACGTGGCGTATTAAC</a:t>
                      </a: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jlpVIP-FLR1</a:t>
                      </a:r>
                      <a:endParaRPr lang="en-US" sz="600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pt-BR" sz="600" kern="100" dirty="0">
                          <a:effectLst/>
                          <a:latin typeface="Courier New" pitchFamily="49" charset="0"/>
                          <a:ea typeface="新細明體"/>
                          <a:cs typeface="Courier New" pitchFamily="49" charset="0"/>
                        </a:rPr>
                        <a:t>GAAGAAATAACCGGGGTGGC</a:t>
                      </a:r>
                      <a:endParaRPr lang="en-US" sz="600" kern="100" dirty="0">
                        <a:effectLst/>
                        <a:latin typeface="Courier New" pitchFamily="49" charset="0"/>
                        <a:ea typeface="新細明體"/>
                        <a:cs typeface="Courier New" pitchFamily="49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rowSpan="18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600" b="1" kern="100" dirty="0" err="1" smtClean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jlpPRP</a:t>
                      </a:r>
                      <a:r>
                        <a:rPr lang="en-US" sz="600" b="1" kern="100" dirty="0" smtClean="0">
                          <a:effectLst/>
                          <a:latin typeface="Times New Roman" pitchFamily="18" charset="0"/>
                          <a:ea typeface="新細明體"/>
                          <a:cs typeface="Times New Roman" pitchFamily="18" charset="0"/>
                        </a:rPr>
                        <a:t>/PACAP</a:t>
                      </a:r>
                    </a:p>
                    <a:p>
                      <a:pPr algn="l">
                        <a:spcAft>
                          <a:spcPts val="0"/>
                        </a:spcAft>
                      </a:pPr>
                      <a:endParaRPr lang="en-US" sz="600" b="1" kern="100" dirty="0" smtClean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endParaRPr lang="en-US" sz="600" b="1" kern="100" dirty="0" smtClean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endParaRPr lang="en-US" sz="600" b="1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Partial </a:t>
                      </a: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clone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jlpPACAP-F1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 pitchFamily="49" charset="0"/>
                          <a:ea typeface="新細明體"/>
                          <a:cs typeface="Courier New" pitchFamily="49" charset="0"/>
                        </a:rPr>
                        <a:t>CGCCACTCGGACGGACTATT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err="1" smtClean="0">
                          <a:effectLst/>
                          <a:latin typeface="Times New Roman"/>
                          <a:ea typeface="新細明體"/>
                        </a:rPr>
                        <a:t>jlpPACAP</a:t>
                      </a: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- </a:t>
                      </a: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R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 pitchFamily="49" charset="0"/>
                          <a:ea typeface="新細明體"/>
                          <a:cs typeface="Courier New" pitchFamily="49" charset="0"/>
                        </a:rPr>
                        <a:t>TAGGACGGTGGACAGGTATT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5560">
                <a:tc vMerge="1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endParaRPr lang="en-US" sz="800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5’RACE (1st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AAP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GGCCACGCGTCGACTAGTACGGGIIGGGIIGGGII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064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jlpPACAP-5’R3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CCACCGCATTCGGCTGGACT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380">
                <a:tc vMerge="1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endParaRPr lang="en-US" sz="800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5’RACE (2nd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AUAP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GGCCACGCGTCGACTAGTAC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3460">
                <a:tc vMerge="1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endParaRPr lang="en-US" sz="800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err="1" smtClean="0">
                          <a:effectLst/>
                          <a:latin typeface="Times New Roman"/>
                          <a:ea typeface="新細明體"/>
                        </a:rPr>
                        <a:t>jlpPACAP</a:t>
                      </a: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- </a:t>
                      </a: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5’R4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CCTCTGCCTATACTTGGGGT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endParaRPr lang="en-US" sz="800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3’RACE (1st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err="1" smtClean="0">
                          <a:effectLst/>
                          <a:latin typeface="Times New Roman"/>
                          <a:ea typeface="新細明體"/>
                        </a:rPr>
                        <a:t>jlpPACAP</a:t>
                      </a: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- </a:t>
                      </a: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3’F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ACGGCAGAAAGGCGGCCAAG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AUAP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GGCCACGCGTCGACTAGTAC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3300">
                <a:tc vMerge="1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endParaRPr lang="en-US" sz="800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3’RACE (2nd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jlpPACAP-3’F2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AAGACGGTGACGATGGCAGC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27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AUAP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GGCCACGCGTCGACTAGTAC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endParaRPr lang="en-US" sz="800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Full </a:t>
                      </a: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length clone (</a:t>
                      </a: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1st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jlpPACAP-FLF1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GACTGAGAAATCCGTTCCTC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jlpPACAP-FLR1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TACCACCGCATTCGGCTGGA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8220">
                <a:tc vMerge="1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endParaRPr lang="en-US" sz="800" kern="100" dirty="0">
                        <a:effectLst/>
                        <a:latin typeface="Times New Roman" pitchFamily="18" charset="0"/>
                        <a:ea typeface="新細明體"/>
                        <a:cs typeface="Times New Roman" pitchFamily="18" charset="0"/>
                      </a:endParaRPr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Full length </a:t>
                      </a: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clone (2nd </a:t>
                      </a: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round</a:t>
                      </a: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)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endParaRPr lang="en-US" sz="600" kern="100" dirty="0" smtClean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jlpPACAP-FLF2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CAAAGCACCGCGGAATGATG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 sz="800" dirty="0"/>
                    </a:p>
                  </a:txBody>
                  <a:tcPr marL="67883" marR="6788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jlpPACAP-FLR2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Courier New"/>
                          <a:ea typeface="新細明體"/>
                        </a:rPr>
                        <a:t>GAAGAAATACCACCGCATTC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Real time PCR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err="1" smtClean="0">
                          <a:effectLst/>
                          <a:latin typeface="Times New Roman"/>
                          <a:ea typeface="新細明體"/>
                        </a:rPr>
                        <a:t>jlpPACAP</a:t>
                      </a: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-RT-F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Courier New" pitchFamily="49" charset="0"/>
                          <a:ea typeface="新細明體"/>
                          <a:cs typeface="Courier New" pitchFamily="49" charset="0"/>
                        </a:rPr>
                        <a:t>ATCACGCCCTCTACGACCTC</a:t>
                      </a:r>
                      <a:endParaRPr lang="en-US" sz="600" kern="100" dirty="0">
                        <a:effectLst/>
                        <a:latin typeface="Courier New" pitchFamily="49" charset="0"/>
                        <a:ea typeface="新細明體"/>
                        <a:cs typeface="Courier New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err="1" smtClean="0">
                          <a:effectLst/>
                          <a:latin typeface="Times New Roman"/>
                          <a:ea typeface="新細明體"/>
                        </a:rPr>
                        <a:t>jlpPACAP</a:t>
                      </a: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-RT-R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Courier New" pitchFamily="49" charset="0"/>
                          <a:ea typeface="新細明體"/>
                          <a:cs typeface="Courier New" pitchFamily="49" charset="0"/>
                        </a:rPr>
                        <a:t>GGGGTACTTTCTCTTGCCTA</a:t>
                      </a:r>
                      <a:endParaRPr lang="en-US" sz="600" kern="100" dirty="0">
                        <a:effectLst/>
                        <a:latin typeface="Courier New" pitchFamily="49" charset="0"/>
                        <a:ea typeface="新細明體"/>
                        <a:cs typeface="Courier New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768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β-actin real time PCR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kern="100" dirty="0" err="1" smtClean="0">
                          <a:effectLst/>
                          <a:latin typeface="Times New Roman"/>
                          <a:ea typeface="新細明體"/>
                        </a:rPr>
                        <a:t>jlp</a:t>
                      </a: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-β-actin-F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Courier New" pitchFamily="49" charset="0"/>
                          <a:ea typeface="新細明體"/>
                          <a:cs typeface="Courier New" pitchFamily="49" charset="0"/>
                        </a:rPr>
                        <a:t>AGAAGATCTGGCACCACACC</a:t>
                      </a:r>
                      <a:endParaRPr lang="en-US" sz="600" kern="100" dirty="0">
                        <a:effectLst/>
                        <a:latin typeface="Courier New" pitchFamily="49" charset="0"/>
                        <a:ea typeface="新細明體"/>
                        <a:cs typeface="Courier New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kern="100" dirty="0" err="1" smtClean="0">
                          <a:effectLst/>
                          <a:latin typeface="Times New Roman"/>
                          <a:ea typeface="新細明體"/>
                        </a:rPr>
                        <a:t>jlp</a:t>
                      </a: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-β-actin-R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Courier New" pitchFamily="49" charset="0"/>
                          <a:ea typeface="新細明體"/>
                          <a:cs typeface="Courier New" pitchFamily="49" charset="0"/>
                        </a:rPr>
                        <a:t>GCACAGCTTCTCCTTGATGTC</a:t>
                      </a:r>
                      <a:endParaRPr lang="en-US" sz="600" kern="100" dirty="0">
                        <a:effectLst/>
                        <a:latin typeface="Courier New" pitchFamily="49" charset="0"/>
                        <a:ea typeface="新細明體"/>
                        <a:cs typeface="Courier New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rowSpan="10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b="1" kern="100" dirty="0" err="1" smtClean="0">
                          <a:effectLst/>
                          <a:latin typeface="Times New Roman"/>
                          <a:ea typeface="新細明體"/>
                        </a:rPr>
                        <a:t>jlpVPAC</a:t>
                      </a:r>
                      <a:endParaRPr lang="en-US" sz="600" b="1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Partial clone of </a:t>
                      </a:r>
                      <a:r>
                        <a:rPr lang="en-US" sz="600" kern="100" dirty="0" err="1">
                          <a:effectLst/>
                          <a:latin typeface="Times New Roman"/>
                          <a:ea typeface="新細明體"/>
                        </a:rPr>
                        <a:t>lpVPAC</a:t>
                      </a: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 (1st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G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TGCAYTGYACNMGNAAYTAYATYCA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720">
                <a:tc vMerge="1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G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pt-BR" sz="600" kern="100">
                          <a:effectLst/>
                          <a:latin typeface="Courier New"/>
                          <a:ea typeface="新細明體"/>
                        </a:rPr>
                        <a:t>TGSACCTTCNCCRTTNASRAARCARTA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Partial clone of lpVPAC (2nd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G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TGCAYTGYACNMGNAAYTAYATYCA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G6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AGSGGGATSAGSRKNAGNGTGGAYTT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5’RACE (1st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AAP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GGCCACGCGTCGACTAGTACGGGIIGGGIIGGGII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60960">
                <a:tc vMerge="1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lpVPAC-5’R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TGGCCATGATGCAGTCACTGG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5’RACE (2nd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AUAP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GGCCACGCGTCGACTAGTAC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lpVPAC-5’R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TCCATGTCATCGAAGTACTC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3’RAC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lpVPAC-3’F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CTCATCAAGAAGCTCAAGTC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AUAP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GGCCACGCGTCGACTAGTAC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rowSpan="26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b="1" kern="100" dirty="0" err="1" smtClean="0">
                          <a:effectLst/>
                          <a:latin typeface="Times New Roman"/>
                          <a:ea typeface="新細明體"/>
                        </a:rPr>
                        <a:t>hfVPACa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Partial clone </a:t>
                      </a: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(</a:t>
                      </a: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1st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G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TGCAYTGYACNMGNAAYTAYATYCA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 sz="600" dirty="0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G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pt-BR" sz="600" kern="100">
                          <a:effectLst/>
                          <a:latin typeface="Courier New"/>
                          <a:ea typeface="新細明體"/>
                        </a:rPr>
                        <a:t>TGSACCTTCNCCRTTNASRAARCARTA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Partial clone </a:t>
                      </a: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(</a:t>
                      </a: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2nd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G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TGCAYTGYACNMGNAAYTAYATYCA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 sz="600" dirty="0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G6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AGSGGGATSAGSRKNAGNGTGGAYTT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Amplification of 5’ cDNA end (1st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T3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CCCTTTAGTGAGGGTTAATT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 sz="600" dirty="0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hfVPACa-5’R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CCATCCTCCTGAAGTACC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Amplification of 5’ cDNA end (2nd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T3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CCCTTTAGTGAGGGTTAATT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 sz="600" dirty="0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hfVPACa-5’R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CCCTTCCTCTTCATCCAGTTG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Amplification of 3’ cDNA end-I (1st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hfVPACa-3’F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GGAGGGAATGATTGCAGCCA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 sz="600" dirty="0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T3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CCCTTTAGTGAGGGTTAATT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Amplification of 3’ cDNA end-I (2nd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hfVPACa-3’F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TCGCGTTCACTCCAGACATG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 sz="600" dirty="0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T3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CCCTTTAGTGAGGGTTAATT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Amplification of 3’ cDNA end-II (1st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a-3’F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GGAGGGAATGATTGCAGCCA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 sz="600" dirty="0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a-3’R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kern="100" dirty="0" smtClean="0">
                          <a:effectLst/>
                          <a:latin typeface="Courier New"/>
                          <a:ea typeface="新細明體"/>
                        </a:rPr>
                        <a:t>CCATCCTCCTGAAGTACC</a:t>
                      </a:r>
                      <a:endParaRPr lang="en-US" sz="600" kern="100" dirty="0" smtClean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Amplification of 3’ cDNA end-II (2nd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a-3’F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TCGCGTTCACTCCAGACATG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 sz="600" dirty="0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a-3’R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kern="100" dirty="0" smtClean="0">
                          <a:effectLst/>
                          <a:latin typeface="Courier New"/>
                          <a:ea typeface="新細明體"/>
                        </a:rPr>
                        <a:t>CCCTTCCTCTTCATCCAGTTG</a:t>
                      </a:r>
                      <a:endParaRPr lang="en-US" sz="600" kern="100" dirty="0" smtClean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Full length clone </a:t>
                      </a: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(</a:t>
                      </a: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1st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a-FLF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CAGGAATTCAGGGACTGGAGGCTAATC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 sz="600" dirty="0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a-FLR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CTCGAGGCACATCTTCCTGTGAAG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Full length clone </a:t>
                      </a: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(</a:t>
                      </a: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2nd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a-FLF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CAGGAATTCAGGGACTGGAGGCTAATC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 sz="600" dirty="0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a-FLR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CTCGAGCATTCTCATATCCGGTTA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err="1" smtClean="0">
                          <a:effectLst/>
                          <a:latin typeface="Times New Roman"/>
                          <a:ea typeface="新細明體"/>
                        </a:rPr>
                        <a:t>Riboprobe</a:t>
                      </a: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 </a:t>
                      </a: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preparation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a-ISH-F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TGTCCATCCTTCATCGTTAT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 sz="600" dirty="0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a-5’R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CCCTTCCTCTTCATCCAGTTG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Real time </a:t>
                      </a: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PCR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a-3’F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TCGCGTTCACTCCAGACATG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 sz="600" dirty="0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a-RT-R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CGTAGCTCCAGTCTCC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609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β-actin real time PCR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err="1" smtClean="0">
                          <a:effectLst/>
                          <a:latin typeface="Times New Roman"/>
                          <a:ea typeface="新細明體"/>
                        </a:rPr>
                        <a:t>hf</a:t>
                      </a: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-β-actin-F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GTCGCACCTGAAGAACATCC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609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err="1" smtClean="0">
                          <a:effectLst/>
                          <a:latin typeface="Times New Roman"/>
                          <a:ea typeface="新細明體"/>
                        </a:rPr>
                        <a:t>hf</a:t>
                      </a: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-β-actin-R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TGTCTCCCATACCGTGCC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rowSpan="26">
                  <a:txBody>
                    <a:bodyPr/>
                    <a:lstStyle/>
                    <a:p>
                      <a:r>
                        <a:rPr lang="en-US" sz="600" b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hfVPACb</a:t>
                      </a:r>
                      <a:endParaRPr lang="en-US" sz="6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Partial clone </a:t>
                      </a: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(1st </a:t>
                      </a: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b-PF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CACTGYATGAGRAAYWACATYCA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7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G6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AGSGGGATSAGSRKNAGNGTGGAYTT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 sz="600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Partial clone </a:t>
                      </a: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(</a:t>
                      </a: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2nd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b-PF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CACTGYATGAGRAAYWACATYCA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7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G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pt-BR" sz="600" kern="100">
                          <a:effectLst/>
                          <a:latin typeface="Courier New"/>
                          <a:ea typeface="新細明體"/>
                        </a:rPr>
                        <a:t>TGSACCTTCNCCRTTNASRAARCARTA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480">
                <a:tc vMerge="1">
                  <a:txBody>
                    <a:bodyPr/>
                    <a:lstStyle/>
                    <a:p>
                      <a:endParaRPr lang="en-US" sz="600" dirty="0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5’RACE-I (1st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GeneRacer</a:t>
                      </a:r>
                      <a:r>
                        <a:rPr lang="en-US" sz="600" kern="100" baseline="30000">
                          <a:effectLst/>
                          <a:latin typeface="Times New Roman"/>
                          <a:ea typeface="新細明體"/>
                        </a:rPr>
                        <a:t>TM</a:t>
                      </a: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 5’Primer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CGACTGGAGCACGAGGACACTGA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48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b- 5’R2A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AGGAGCCAGCTAAAGTTGGC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480">
                <a:tc vMerge="1">
                  <a:txBody>
                    <a:bodyPr/>
                    <a:lstStyle/>
                    <a:p>
                      <a:endParaRPr lang="en-US" sz="600" dirty="0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5’RACE-I (2nd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GeneRacer</a:t>
                      </a:r>
                      <a:r>
                        <a:rPr lang="en-US" sz="600" kern="100" baseline="30000">
                          <a:effectLst/>
                          <a:latin typeface="Times New Roman"/>
                          <a:ea typeface="新細明體"/>
                        </a:rPr>
                        <a:t>TM</a:t>
                      </a: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 5’Nested Primer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GGACACTGACATGGACTGAAGGAGTA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609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b- 5’R3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ATTGCCATCTTGCACCACACAAGCA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 sz="600" dirty="0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5’RACE-II (1st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GeneRacer</a:t>
                      </a:r>
                      <a:r>
                        <a:rPr lang="en-US" sz="600" kern="100" baseline="30000">
                          <a:effectLst/>
                          <a:latin typeface="Times New Roman"/>
                          <a:ea typeface="新細明體"/>
                        </a:rPr>
                        <a:t>TM</a:t>
                      </a: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 5’Primer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CGACTGGAGCACGAGGACACTGA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b 5’R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AGAGATGCATGTGAATGTAG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720">
                <a:tc vMerge="1">
                  <a:txBody>
                    <a:bodyPr/>
                    <a:lstStyle/>
                    <a:p>
                      <a:endParaRPr lang="en-US" sz="600" dirty="0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5’RACE-II (2nd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GeneRacer</a:t>
                      </a:r>
                      <a:r>
                        <a:rPr lang="en-US" sz="600" kern="100" baseline="30000">
                          <a:effectLst/>
                          <a:latin typeface="Times New Roman"/>
                          <a:ea typeface="新細明體"/>
                        </a:rPr>
                        <a:t>TM</a:t>
                      </a: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 5’Nested Primer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GGACACTGACATGGACTGAAGGAGTA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7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b-5’R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TGAAGTTTCCGGAACATGCA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480">
                <a:tc vMerge="1">
                  <a:txBody>
                    <a:bodyPr/>
                    <a:lstStyle/>
                    <a:p>
                      <a:endParaRPr lang="en-US" sz="600" dirty="0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3’RACE-I (1st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b-3’ F3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ATGCCTACATCTGGTACATC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T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pt-BR" sz="600" kern="100">
                          <a:effectLst/>
                          <a:latin typeface="Courier New"/>
                          <a:ea typeface="新細明體"/>
                        </a:rPr>
                        <a:t>GTAATACGACTCACTATAGGGC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 sz="600" dirty="0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3’RACE-II (2nd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b-3’ F4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TGCTGTTTATCAGCATCATC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609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T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pt-BR" sz="600" kern="100">
                          <a:effectLst/>
                          <a:latin typeface="Courier New"/>
                          <a:ea typeface="新細明體"/>
                        </a:rPr>
                        <a:t>GTAATACGACTCACTATAGGGC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720">
                <a:tc vMerge="1">
                  <a:txBody>
                    <a:bodyPr/>
                    <a:lstStyle/>
                    <a:p>
                      <a:endParaRPr lang="en-US" sz="600" dirty="0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Full length clone </a:t>
                      </a: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(</a:t>
                      </a: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1st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b- FLF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GAATTCAGGCAGGAGGGCGTTCATCC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b-FLR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CTCGAGGAGAGATGAAAGCAGCAGAA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480">
                <a:tc vMerge="1">
                  <a:txBody>
                    <a:bodyPr/>
                    <a:lstStyle/>
                    <a:p>
                      <a:endParaRPr lang="en-US" sz="600" dirty="0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Full length clone </a:t>
                      </a: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(</a:t>
                      </a: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2nd roun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b-FLF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GAATTCTGTTTGACCTCCAGCCTCGG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609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b-FLR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CTCGAGGTCGTACCGTAGTCAAGATT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 sz="600" dirty="0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err="1" smtClean="0">
                          <a:effectLst/>
                          <a:latin typeface="Times New Roman"/>
                          <a:ea typeface="新細明體"/>
                        </a:rPr>
                        <a:t>Riboprobe</a:t>
                      </a: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 preparation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b-ISH-F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ACGCCTCATGATTGTTTCCATGCC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7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b- ISH-R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AAGAGCTGCATTAACGTATAATGG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 sz="600" dirty="0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Real </a:t>
                      </a:r>
                      <a:r>
                        <a:rPr lang="en-US" sz="600" kern="100" dirty="0">
                          <a:effectLst/>
                          <a:latin typeface="Times New Roman"/>
                          <a:ea typeface="新細明體"/>
                        </a:rPr>
                        <a:t>time PCR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b-RT-F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CTGAATGATGTTGCCATGAA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48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Times New Roman"/>
                          <a:ea typeface="新細明體"/>
                        </a:rPr>
                        <a:t>hfVPACb-RT-R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GGACGACTCTGTGTACATCT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60960">
                <a:tc vMerge="1">
                  <a:txBody>
                    <a:bodyPr/>
                    <a:lstStyle/>
                    <a:p>
                      <a:endParaRPr lang="en-US" sz="600" dirty="0"/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smtClean="0">
                          <a:effectLst/>
                          <a:latin typeface="Times New Roman"/>
                          <a:ea typeface="新細明體"/>
                        </a:rPr>
                        <a:t>β-actin real time PCR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err="1" smtClean="0">
                          <a:effectLst/>
                          <a:latin typeface="Times New Roman"/>
                          <a:ea typeface="新細明體"/>
                        </a:rPr>
                        <a:t>hf</a:t>
                      </a: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-β-actin-F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>
                          <a:effectLst/>
                          <a:latin typeface="Courier New"/>
                          <a:ea typeface="新細明體"/>
                        </a:rPr>
                        <a:t>GTCGCACCTGAAGAACATCC</a:t>
                      </a:r>
                      <a:endParaRPr lang="en-US" sz="600" kern="10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 err="1" smtClean="0">
                          <a:effectLst/>
                          <a:latin typeface="Times New Roman"/>
                          <a:ea typeface="新細明體"/>
                        </a:rPr>
                        <a:t>hf</a:t>
                      </a:r>
                      <a:r>
                        <a:rPr lang="en-US" sz="600" kern="100" dirty="0" smtClean="0">
                          <a:effectLst/>
                          <a:latin typeface="Times New Roman"/>
                          <a:ea typeface="新細明體"/>
                        </a:rPr>
                        <a:t>-β-actin-R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Courier New"/>
                          <a:ea typeface="新細明體"/>
                        </a:rPr>
                        <a:t>TGTCTCCCATACCGTGCC</a:t>
                      </a:r>
                      <a:endParaRPr lang="en-US" sz="600" kern="100" dirty="0">
                        <a:effectLst/>
                        <a:latin typeface="Times New Roman"/>
                        <a:ea typeface="新細明體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-25419" y="-48399"/>
            <a:ext cx="7104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Table S1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9774729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62</TotalTime>
  <Words>773</Words>
  <Application>Microsoft Macintosh PowerPoint</Application>
  <PresentationFormat>On-screen Show (4:3)</PresentationFormat>
  <Paragraphs>24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o</dc:creator>
  <cp:lastModifiedBy>Leo Lee</cp:lastModifiedBy>
  <cp:revision>173</cp:revision>
  <cp:lastPrinted>2011-04-04T08:17:36Z</cp:lastPrinted>
  <dcterms:created xsi:type="dcterms:W3CDTF">2011-03-21T07:06:05Z</dcterms:created>
  <dcterms:modified xsi:type="dcterms:W3CDTF">2012-08-13T03:43:07Z</dcterms:modified>
</cp:coreProperties>
</file>